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531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947"/>
    <p:restoredTop sz="94665"/>
  </p:normalViewPr>
  <p:slideViewPr>
    <p:cSldViewPr snapToGrid="0" snapToObjects="1" showGuides="1">
      <p:cViewPr varScale="1">
        <p:scale>
          <a:sx n="131" d="100"/>
          <a:sy n="131" d="100"/>
        </p:scale>
        <p:origin x="184" y="312"/>
      </p:cViewPr>
      <p:guideLst>
        <p:guide orient="horz" pos="2160"/>
        <p:guide pos="53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C4B5C33-C947-4F43-B5AA-B37A4D9F29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A39CEE10-0A44-2647-87A6-8C0C04FD2E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C04295A-D9DE-EA4E-8FD9-AC7BEA72F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6EA75AF-6F30-6646-9D56-ECF490B56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F03D90-1A81-4F45-8A6A-997AF4E17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874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409D55-774C-264D-81FB-747971129C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BAFCDB9-59C5-E748-A6F1-D9118301D3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DE8A-359C-694F-BC98-92242BFFB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899A8A-D023-0A42-BEA9-FA14F2B3E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C093F82-CFAA-B84A-815E-EBB7DB163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8177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55B5C39-BC09-7746-AF36-4593C2B360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692163A-21BD-C749-87F8-3EC85A0611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83D3B2A-1B0F-6841-B438-07F4CBD43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F0D973-489F-954E-B55F-9856D7B7B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AE8A15-F150-AF45-878C-B0AA80506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2403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1701BB-7F95-9345-9081-B71F57355C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FA2E1B5-F515-7042-A79E-344BCC28FC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9EDD8E-3135-2240-9BEF-19B64BFC7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10EF4A6-18E3-8148-BBA5-4A323ED34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807D0EA-894F-F44B-B251-0FDF2E4E3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4361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22B6CF1-0B4B-9B4D-8A53-64288DD8FB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3318F0F-0A80-E446-8D4D-BD56F93DA5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61725D7-B39D-0743-B8C8-011A3AF3A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D0A4056-2A6A-524B-BC6F-F9174BEEF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ACBD5D3-FD7F-1B4B-8A54-1D0BB5E1A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13483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A8449D-706B-464A-9560-847A8905EB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51B3F75-FABD-2043-8111-2CC69E397C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4B26949-76B8-724B-AFFD-B1946F8CF1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A1DB6CA-F112-B748-AF6B-D098A0FAA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CB76A7B-9221-0648-BE3F-A66581369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14AED94-EC39-994B-A171-887FFCA55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8828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A17DF4F-0559-EA4D-82DE-A7BC9A9C15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0A17E86-B854-4744-9ACC-B68CC5A647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073FDAF-7B13-C64D-B940-FEC94BCC0B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7BCAEF81-78AC-6F4E-8D97-ED3991C365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F7837054-BE6A-B44D-96E5-355C64E604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3757380-E859-5542-9350-20468DE55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8F5B9A2D-4626-2B42-A21C-6FC98E1ED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71A6F21-493F-7549-9530-DEECCCA2C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2848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A0AC4A1-0EC9-5E40-93F9-25D9F9ED10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C9C6722-8FD0-414E-8B0C-B8C6CABC4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134A9CD0-D672-D743-B4FA-0F8DEF898D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13FCF5F-2CF0-C948-A326-9BB5112B2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756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E4DEAB4-05AA-5A43-A920-794C50091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76A12133-5158-3644-A3C3-979028B798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49AA091-BD0A-EE4C-BDBF-553230D92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9911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F76997E-4414-8A42-89EA-D0CF97B7E4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4AA9B23-805A-D844-BE76-F7B4D0F006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8A2609D-3969-8F40-BEA9-69677C5DC5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B9C44BB-E98C-DE44-AB19-C5BCCDE99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8D6EE78-DA52-CD46-AED8-B18DF446E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58B3245-DA5E-9349-B2F7-B8F3C8315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5204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08E2191-D74D-6F40-8E13-CDC68AF9B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C6B3DD8-6098-5C44-818C-4AE8E40EE3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91F1E1C-0F1E-3B45-A25B-C493EC5462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7546C1E-7E0F-7F45-9018-238E1C92A9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E36574E-8B1E-EC4B-AAE9-F3F7F5976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5B3AAC9-3A98-9543-8923-171A31F4A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1222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5B5ADE0-CE7E-504E-9552-2E22B35FA0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37E24C2-73A3-024B-8F68-31A133333A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A6FE35A-CE8F-E143-965A-7C8DD2D9C7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BA552-27E6-1C4F-A924-BA418381154C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873ECE9-5DC7-DC41-A63F-43DAA04704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0089545-DE3B-0B44-8B05-FA707E3DEE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9B9CE-ACC6-DF45-BEE7-8F9E47B09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7470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e 6">
            <a:extLst>
              <a:ext uri="{FF2B5EF4-FFF2-40B4-BE49-F238E27FC236}">
                <a16:creationId xmlns:a16="http://schemas.microsoft.com/office/drawing/2014/main" id="{E28B274F-58D3-A747-A671-57CF944CAEE9}"/>
              </a:ext>
            </a:extLst>
          </p:cNvPr>
          <p:cNvGrpSpPr>
            <a:grpSpLocks noChangeAspect="1"/>
          </p:cNvGrpSpPr>
          <p:nvPr/>
        </p:nvGrpSpPr>
        <p:grpSpPr>
          <a:xfrm>
            <a:off x="3465807" y="372616"/>
            <a:ext cx="4868537" cy="3935769"/>
            <a:chOff x="1247571" y="372616"/>
            <a:chExt cx="4868537" cy="3935769"/>
          </a:xfrm>
        </p:grpSpPr>
        <p:grpSp>
          <p:nvGrpSpPr>
            <p:cNvPr id="17" name="Groupe 16">
              <a:extLst>
                <a:ext uri="{FF2B5EF4-FFF2-40B4-BE49-F238E27FC236}">
                  <a16:creationId xmlns:a16="http://schemas.microsoft.com/office/drawing/2014/main" id="{5BE3BF03-CEF6-CD48-AD29-B63FE8FC97C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247571" y="805008"/>
              <a:ext cx="3370879" cy="3240000"/>
              <a:chOff x="1036360" y="550295"/>
              <a:chExt cx="3809338" cy="3661437"/>
            </a:xfrm>
          </p:grpSpPr>
          <p:grpSp>
            <p:nvGrpSpPr>
              <p:cNvPr id="2" name="Groupe 1">
                <a:extLst>
                  <a:ext uri="{FF2B5EF4-FFF2-40B4-BE49-F238E27FC236}">
                    <a16:creationId xmlns:a16="http://schemas.microsoft.com/office/drawing/2014/main" id="{0CB985EA-D432-2E48-928C-6B503F4895E3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036360" y="550295"/>
                <a:ext cx="3607200" cy="3661437"/>
                <a:chOff x="5664112" y="1268760"/>
                <a:chExt cx="2952008" cy="2996400"/>
              </a:xfrm>
            </p:grpSpPr>
            <p:pic>
              <p:nvPicPr>
                <p:cNvPr id="8" name="Picture 4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664112" y="1840340"/>
                  <a:ext cx="1440000" cy="148423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9" name="Picture 5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104112" y="1268760"/>
                  <a:ext cx="1440000" cy="148423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1" name="Picture 7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176120" y="2780928"/>
                  <a:ext cx="1440000" cy="148423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 xmlns="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cxnSp>
              <p:nvCxnSpPr>
                <p:cNvPr id="15" name="Connecteur droit avec flèche 14"/>
                <p:cNvCxnSpPr>
                  <a:cxnSpLocks/>
                </p:cNvCxnSpPr>
                <p:nvPr/>
              </p:nvCxnSpPr>
              <p:spPr>
                <a:xfrm>
                  <a:off x="6240016" y="2204864"/>
                  <a:ext cx="936104" cy="0"/>
                </a:xfrm>
                <a:prstGeom prst="straightConnector1">
                  <a:avLst/>
                </a:prstGeom>
                <a:ln w="15875">
                  <a:solidFill>
                    <a:schemeClr val="tx1"/>
                  </a:solidFill>
                  <a:headEnd type="oval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Connecteur droit avec flèche 31"/>
                <p:cNvCxnSpPr/>
                <p:nvPr/>
              </p:nvCxnSpPr>
              <p:spPr>
                <a:xfrm>
                  <a:off x="6168008" y="2852936"/>
                  <a:ext cx="1080120" cy="216024"/>
                </a:xfrm>
                <a:prstGeom prst="straightConnector1">
                  <a:avLst/>
                </a:prstGeom>
                <a:ln w="15875">
                  <a:solidFill>
                    <a:schemeClr val="tx1"/>
                  </a:solidFill>
                  <a:headEnd type="oval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" name="ZoneTexte 2">
                <a:extLst>
                  <a:ext uri="{FF2B5EF4-FFF2-40B4-BE49-F238E27FC236}">
                    <a16:creationId xmlns:a16="http://schemas.microsoft.com/office/drawing/2014/main" id="{8092C669-926E-CE42-AECC-C4D51FB52EFB}"/>
                  </a:ext>
                </a:extLst>
              </p:cNvPr>
              <p:cNvSpPr txBox="1"/>
              <p:nvPr/>
            </p:nvSpPr>
            <p:spPr>
              <a:xfrm>
                <a:off x="3480505" y="694667"/>
                <a:ext cx="569387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D1</a:t>
                </a:r>
                <a:r>
                  <a:rPr lang="fr-F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T</a:t>
                </a:r>
                <a:r>
                  <a:rPr lang="fr-FR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FH</a:t>
                </a:r>
              </a:p>
            </p:txBody>
          </p:sp>
          <p:sp>
            <p:nvSpPr>
              <p:cNvPr id="13" name="ZoneTexte 12">
                <a:extLst>
                  <a:ext uri="{FF2B5EF4-FFF2-40B4-BE49-F238E27FC236}">
                    <a16:creationId xmlns:a16="http://schemas.microsoft.com/office/drawing/2014/main" id="{AE7C1CC4-DA64-C347-8682-6CF255DBF75D}"/>
                  </a:ext>
                </a:extLst>
              </p:cNvPr>
              <p:cNvSpPr txBox="1"/>
              <p:nvPr/>
            </p:nvSpPr>
            <p:spPr>
              <a:xfrm>
                <a:off x="4021341" y="2553488"/>
                <a:ext cx="824357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XCR5</a:t>
                </a:r>
                <a:r>
                  <a:rPr lang="fr-F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hi</a:t>
                </a:r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T</a:t>
                </a:r>
                <a:r>
                  <a:rPr lang="fr-FR" sz="7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FH</a:t>
                </a:r>
              </a:p>
            </p:txBody>
          </p:sp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BDA2BE33-0E74-1441-B388-7DD1968BFDDC}"/>
                  </a:ext>
                </a:extLst>
              </p:cNvPr>
              <p:cNvSpPr txBox="1"/>
              <p:nvPr/>
            </p:nvSpPr>
            <p:spPr>
              <a:xfrm>
                <a:off x="3854508" y="3382610"/>
                <a:ext cx="649534" cy="22607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XCR5</a:t>
                </a:r>
                <a:r>
                  <a:rPr lang="fr-F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int</a:t>
                </a:r>
                <a:endParaRPr lang="fr-FR" sz="7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ZoneTexte 15">
                <a:extLst>
                  <a:ext uri="{FF2B5EF4-FFF2-40B4-BE49-F238E27FC236}">
                    <a16:creationId xmlns:a16="http://schemas.microsoft.com/office/drawing/2014/main" id="{DF3791F1-45C9-EC43-8E41-59F706846019}"/>
                  </a:ext>
                </a:extLst>
              </p:cNvPr>
              <p:cNvSpPr txBox="1"/>
              <p:nvPr/>
            </p:nvSpPr>
            <p:spPr>
              <a:xfrm>
                <a:off x="3332986" y="3790951"/>
                <a:ext cx="723870" cy="20005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XCR5</a:t>
                </a:r>
                <a:r>
                  <a:rPr lang="fr-F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lo</a:t>
                </a:r>
                <a:endParaRPr lang="fr-FR" sz="7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E4444790-0519-9046-8643-09B1B41400F1}"/>
                </a:ext>
              </a:extLst>
            </p:cNvPr>
            <p:cNvSpPr txBox="1"/>
            <p:nvPr/>
          </p:nvSpPr>
          <p:spPr>
            <a:xfrm>
              <a:off x="1286225" y="372617"/>
              <a:ext cx="2585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F46BCEAE-D811-3247-A1B3-BC8FB922B274}"/>
                </a:ext>
              </a:extLst>
            </p:cNvPr>
            <p:cNvSpPr txBox="1"/>
            <p:nvPr/>
          </p:nvSpPr>
          <p:spPr>
            <a:xfrm>
              <a:off x="4724395" y="37261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E5BE21F4-4903-6E4E-9CCC-3CE734ABC45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20263" y="708385"/>
              <a:ext cx="1495845" cy="3600000"/>
            </a:xfrm>
            <a:prstGeom prst="rect">
              <a:avLst/>
            </a:prstGeom>
          </p:spPr>
        </p:pic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5CDA62FD-C8C7-AB4C-806E-847053FE205C}"/>
              </a:ext>
            </a:extLst>
          </p:cNvPr>
          <p:cNvSpPr/>
          <p:nvPr/>
        </p:nvSpPr>
        <p:spPr>
          <a:xfrm>
            <a:off x="3589506" y="4336377"/>
            <a:ext cx="4846469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4. Various memory CD4 T-cell subsets defined according to the expression of PD1 and ICOS vs. PD1 and CXCR5. 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ison was performed for 4 macaques of each group where spleen cells were stained with Panel 8 (PD1, ICOS) or Panel 9 (PD1, CXCR5)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able S3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.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Gating strategies are shown for one Placebo macaque.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For each group of macaques, percentages of each mCD4 T-cell subset obtained for either staining were plotted. Box-and-whiskers (5-95 percentile) plots with horizontal bars indicating Median values are shown.</a:t>
            </a:r>
            <a:endParaRPr lang="fr-FR" sz="1200" dirty="0"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29783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113</Words>
  <Application>Microsoft Macintosh PowerPoint</Application>
  <PresentationFormat>Grand écran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MS Mincho</vt:lpstr>
      <vt:lpstr>Arial</vt:lpstr>
      <vt:lpstr>Calibri</vt:lpstr>
      <vt:lpstr>Calibri Light</vt:lpstr>
      <vt:lpstr>Cambria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lande RICHARD</dc:creator>
  <cp:lastModifiedBy>Yolande RICHARD</cp:lastModifiedBy>
  <cp:revision>14</cp:revision>
  <cp:lastPrinted>2019-04-26T16:59:58Z</cp:lastPrinted>
  <dcterms:created xsi:type="dcterms:W3CDTF">2019-04-12T15:13:18Z</dcterms:created>
  <dcterms:modified xsi:type="dcterms:W3CDTF">2020-01-27T09:57:23Z</dcterms:modified>
</cp:coreProperties>
</file>